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000000"/>
                </a:solidFill>
                <a:latin typeface="굴림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맑은 고딕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4D48A9C-F937-401C-94C5-5F7AD194F19E}" type="slidenum">
              <a:rPr b="0" lang="ko-KR" sz="12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5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ko-KR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2" name="슬라이드 번호 개체 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930676D-27EC-492A-8402-9265C0780B50}" type="slidenum">
              <a:rPr b="0" lang="ko-KR" sz="12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7F44EE-0A2C-4F17-810D-0C5D82BDD22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485532-941D-49D2-A053-380106C864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E92050-B13A-47AC-B187-4FCC2C3399D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4D9E2C-6042-4682-B5B1-C5026560724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3BBEFC-AA3E-41DB-A101-1D9D393DD7B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8943C3-0FFD-4F5B-9812-971ACBA014D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283EF8-3790-4D9A-B9E1-1DE409C00B7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A16008-28DD-441D-B512-720E8703522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DF6E28-E02A-4019-AD95-33551158DB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45EB04-687A-4D87-866E-55E6017D1A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3A5800-28B4-4A6F-ADEE-BC923FE917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B1922B-20BA-4145-8828-6EADD584DD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5050E57-A0A8-46E8-8DB3-EFDA2C9C620F}" type="slidenum"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"/>
          <p:cNvGraphicFramePr/>
          <p:nvPr/>
        </p:nvGraphicFramePr>
        <p:xfrm>
          <a:off x="507960" y="957240"/>
          <a:ext cx="5805360" cy="6499080"/>
        </p:xfrm>
        <a:graphic>
          <a:graphicData uri="http://schemas.openxmlformats.org/drawingml/2006/table">
            <a:tbl>
              <a:tblPr/>
              <a:tblGrid>
                <a:gridCol w="1960560"/>
                <a:gridCol w="762120"/>
                <a:gridCol w="1552320"/>
                <a:gridCol w="1530360"/>
              </a:tblGrid>
              <a:tr h="500040"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Antibod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Clo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Sourc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Expression in tumo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00040"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PTE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Y18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Epitomic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Cytoplasmic &amp; nuclea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500040"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PI3K-p110</a:t>
                      </a:r>
                      <a:r>
                        <a:rPr b="0" lang="ko-KR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α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polyclona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Cell Signaling Technolog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Cytoplasmi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500040"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p-AKT (Ser 473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736E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Cell Signaling Technolog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Cytoplasmic &amp; nuclea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500040"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p-p70S6K (Thr421/Ser424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polyclona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Cell Signaling Technolog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Cytoplasmic &amp; nuclea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500040"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p-S6 (Ser235/236)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polyclona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Cell Signaling Technolog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Cytoplasmic &amp; nuclea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98600"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p-RAF (Ser259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polyclona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Cell Signaling Technolog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Cytoplasmi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500040"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p-p44/42 MAPK (Thr202/Tyr204)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polyclona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Cell Signaling Technolog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Cytoplasmic &amp; nuclea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500040"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HSP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polyclona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Cell Signaling Technolog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Cytoplasmic &amp; nuclea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500040"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SP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Labvis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Nuclea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500040"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P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PgR63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DAKO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Nuclea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500040"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HER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polyclona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DAKO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Membranou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500040"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Ki-6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MIB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DAKO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5720" rIns="45720" tIns="0" bIns="0" anchor="b">
                      <a:noAutofit/>
                    </a:bodyPr>
                    <a:p>
                      <a:pPr algn="just">
                        <a:lnSpc>
                          <a:spcPct val="150000"/>
                        </a:lnSpc>
                        <a:tabLst>
                          <a:tab algn="l" pos="0"/>
                          <a:tab algn="ctr" pos="2698920"/>
                          <a:tab algn="r" pos="539892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Nuclea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b" marL="45720" marR="457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9" name="Rectangle 1"/>
          <p:cNvSpPr/>
          <p:nvPr/>
        </p:nvSpPr>
        <p:spPr>
          <a:xfrm>
            <a:off x="361800" y="446400"/>
            <a:ext cx="5696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ctr" pos="2700360"/>
                <a:tab algn="r" pos="540072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Table. Antibodies used in this study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6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2-10T14:53:32Z</dcterms:created>
  <dc:creator>Administrator</dc:creator>
  <dc:description/>
  <dc:language>en-US</dc:language>
  <cp:lastModifiedBy>SNUBH</cp:lastModifiedBy>
  <dcterms:modified xsi:type="dcterms:W3CDTF">2010-02-24T13:05:08Z</dcterms:modified>
  <cp:revision>96</cp:revision>
  <dc:subject/>
  <dc:title>슬라이드 1</dc:title>
</cp:coreProperties>
</file>